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257" r:id="rId4"/>
    <p:sldId id="263" r:id="rId5"/>
    <p:sldId id="258" r:id="rId6"/>
    <p:sldId id="259" r:id="rId7"/>
    <p:sldId id="264" r:id="rId8"/>
  </p:sldIdLst>
  <p:sldSz cx="6473825" cy="8631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7" d="100"/>
          <a:sy n="87" d="100"/>
        </p:scale>
        <p:origin x="14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5537" y="1412566"/>
            <a:ext cx="5502751" cy="3004950"/>
          </a:xfrm>
        </p:spPr>
        <p:txBody>
          <a:bodyPr anchor="b"/>
          <a:lstStyle>
            <a:lvl1pPr algn="ctr">
              <a:defRPr sz="424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9228" y="4533399"/>
            <a:ext cx="4855369" cy="2083884"/>
          </a:xfrm>
        </p:spPr>
        <p:txBody>
          <a:bodyPr/>
          <a:lstStyle>
            <a:lvl1pPr marL="0" indent="0" algn="ctr">
              <a:buNone/>
              <a:defRPr sz="1699"/>
            </a:lvl1pPr>
            <a:lvl2pPr marL="323698" indent="0" algn="ctr">
              <a:buNone/>
              <a:defRPr sz="1416"/>
            </a:lvl2pPr>
            <a:lvl3pPr marL="647395" indent="0" algn="ctr">
              <a:buNone/>
              <a:defRPr sz="1274"/>
            </a:lvl3pPr>
            <a:lvl4pPr marL="971093" indent="0" algn="ctr">
              <a:buNone/>
              <a:defRPr sz="1133"/>
            </a:lvl4pPr>
            <a:lvl5pPr marL="1294790" indent="0" algn="ctr">
              <a:buNone/>
              <a:defRPr sz="1133"/>
            </a:lvl5pPr>
            <a:lvl6pPr marL="1618488" indent="0" algn="ctr">
              <a:buNone/>
              <a:defRPr sz="1133"/>
            </a:lvl6pPr>
            <a:lvl7pPr marL="1942186" indent="0" algn="ctr">
              <a:buNone/>
              <a:defRPr sz="1133"/>
            </a:lvl7pPr>
            <a:lvl8pPr marL="2265883" indent="0" algn="ctr">
              <a:buNone/>
              <a:defRPr sz="1133"/>
            </a:lvl8pPr>
            <a:lvl9pPr marL="2589581" indent="0" algn="ctr">
              <a:buNone/>
              <a:defRPr sz="1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022242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331511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2831" y="459534"/>
            <a:ext cx="1395919" cy="73145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076" y="459534"/>
            <a:ext cx="4106833" cy="73145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50967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0488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704" y="2151818"/>
            <a:ext cx="5583674" cy="3590355"/>
          </a:xfrm>
        </p:spPr>
        <p:txBody>
          <a:bodyPr anchor="b"/>
          <a:lstStyle>
            <a:lvl1pPr>
              <a:defRPr sz="424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704" y="5776139"/>
            <a:ext cx="5583674" cy="1888083"/>
          </a:xfrm>
        </p:spPr>
        <p:txBody>
          <a:bodyPr/>
          <a:lstStyle>
            <a:lvl1pPr marL="0" indent="0">
              <a:buNone/>
              <a:defRPr sz="1699">
                <a:solidFill>
                  <a:schemeClr val="tx1"/>
                </a:solidFill>
              </a:defRPr>
            </a:lvl1pPr>
            <a:lvl2pPr marL="323698" indent="0">
              <a:buNone/>
              <a:defRPr sz="1416">
                <a:solidFill>
                  <a:schemeClr val="tx1">
                    <a:tint val="75000"/>
                  </a:schemeClr>
                </a:solidFill>
              </a:defRPr>
            </a:lvl2pPr>
            <a:lvl3pPr marL="647395" indent="0">
              <a:buNone/>
              <a:defRPr sz="1274">
                <a:solidFill>
                  <a:schemeClr val="tx1">
                    <a:tint val="75000"/>
                  </a:schemeClr>
                </a:solidFill>
              </a:defRPr>
            </a:lvl3pPr>
            <a:lvl4pPr marL="971093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4pPr>
            <a:lvl5pPr marL="1294790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5pPr>
            <a:lvl6pPr marL="1618488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6pPr>
            <a:lvl7pPr marL="1942186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7pPr>
            <a:lvl8pPr marL="2265883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8pPr>
            <a:lvl9pPr marL="2589581" indent="0">
              <a:buNone/>
              <a:defRPr sz="1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105111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075" y="2297668"/>
            <a:ext cx="2751376" cy="5476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7374" y="2297668"/>
            <a:ext cx="2751376" cy="5476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218836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459535"/>
            <a:ext cx="5583674" cy="166830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919" y="2115853"/>
            <a:ext cx="2738731" cy="1036947"/>
          </a:xfrm>
        </p:spPr>
        <p:txBody>
          <a:bodyPr anchor="b"/>
          <a:lstStyle>
            <a:lvl1pPr marL="0" indent="0">
              <a:buNone/>
              <a:defRPr sz="1699" b="1"/>
            </a:lvl1pPr>
            <a:lvl2pPr marL="323698" indent="0">
              <a:buNone/>
              <a:defRPr sz="1416" b="1"/>
            </a:lvl2pPr>
            <a:lvl3pPr marL="647395" indent="0">
              <a:buNone/>
              <a:defRPr sz="1274" b="1"/>
            </a:lvl3pPr>
            <a:lvl4pPr marL="971093" indent="0">
              <a:buNone/>
              <a:defRPr sz="1133" b="1"/>
            </a:lvl4pPr>
            <a:lvl5pPr marL="1294790" indent="0">
              <a:buNone/>
              <a:defRPr sz="1133" b="1"/>
            </a:lvl5pPr>
            <a:lvl6pPr marL="1618488" indent="0">
              <a:buNone/>
              <a:defRPr sz="1133" b="1"/>
            </a:lvl6pPr>
            <a:lvl7pPr marL="1942186" indent="0">
              <a:buNone/>
              <a:defRPr sz="1133" b="1"/>
            </a:lvl7pPr>
            <a:lvl8pPr marL="2265883" indent="0">
              <a:buNone/>
              <a:defRPr sz="1133" b="1"/>
            </a:lvl8pPr>
            <a:lvl9pPr marL="2589581" indent="0">
              <a:buNone/>
              <a:defRPr sz="1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5919" y="3152799"/>
            <a:ext cx="2738731" cy="463729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77374" y="2115853"/>
            <a:ext cx="2752219" cy="1036947"/>
          </a:xfrm>
        </p:spPr>
        <p:txBody>
          <a:bodyPr anchor="b"/>
          <a:lstStyle>
            <a:lvl1pPr marL="0" indent="0">
              <a:buNone/>
              <a:defRPr sz="1699" b="1"/>
            </a:lvl1pPr>
            <a:lvl2pPr marL="323698" indent="0">
              <a:buNone/>
              <a:defRPr sz="1416" b="1"/>
            </a:lvl2pPr>
            <a:lvl3pPr marL="647395" indent="0">
              <a:buNone/>
              <a:defRPr sz="1274" b="1"/>
            </a:lvl3pPr>
            <a:lvl4pPr marL="971093" indent="0">
              <a:buNone/>
              <a:defRPr sz="1133" b="1"/>
            </a:lvl4pPr>
            <a:lvl5pPr marL="1294790" indent="0">
              <a:buNone/>
              <a:defRPr sz="1133" b="1"/>
            </a:lvl5pPr>
            <a:lvl6pPr marL="1618488" indent="0">
              <a:buNone/>
              <a:defRPr sz="1133" b="1"/>
            </a:lvl6pPr>
            <a:lvl7pPr marL="1942186" indent="0">
              <a:buNone/>
              <a:defRPr sz="1133" b="1"/>
            </a:lvl7pPr>
            <a:lvl8pPr marL="2265883" indent="0">
              <a:buNone/>
              <a:defRPr sz="1133" b="1"/>
            </a:lvl8pPr>
            <a:lvl9pPr marL="2589581" indent="0">
              <a:buNone/>
              <a:defRPr sz="1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77374" y="3152799"/>
            <a:ext cx="2752219" cy="463729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217978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986026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989296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575416"/>
            <a:ext cx="2087977" cy="2013956"/>
          </a:xfrm>
        </p:spPr>
        <p:txBody>
          <a:bodyPr anchor="b"/>
          <a:lstStyle>
            <a:lvl1pPr>
              <a:defRPr sz="2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2219" y="1242740"/>
            <a:ext cx="3277374" cy="6133773"/>
          </a:xfrm>
        </p:spPr>
        <p:txBody>
          <a:bodyPr/>
          <a:lstStyle>
            <a:lvl1pPr>
              <a:defRPr sz="2266"/>
            </a:lvl1pPr>
            <a:lvl2pPr>
              <a:defRPr sz="1982"/>
            </a:lvl2pPr>
            <a:lvl3pPr>
              <a:defRPr sz="1699"/>
            </a:lvl3pPr>
            <a:lvl4pPr>
              <a:defRPr sz="1416"/>
            </a:lvl4pPr>
            <a:lvl5pPr>
              <a:defRPr sz="1416"/>
            </a:lvl5pPr>
            <a:lvl6pPr>
              <a:defRPr sz="1416"/>
            </a:lvl6pPr>
            <a:lvl7pPr>
              <a:defRPr sz="1416"/>
            </a:lvl7pPr>
            <a:lvl8pPr>
              <a:defRPr sz="1416"/>
            </a:lvl8pPr>
            <a:lvl9pPr>
              <a:defRPr sz="141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5919" y="2589371"/>
            <a:ext cx="2087977" cy="4797131"/>
          </a:xfrm>
        </p:spPr>
        <p:txBody>
          <a:bodyPr/>
          <a:lstStyle>
            <a:lvl1pPr marL="0" indent="0">
              <a:buNone/>
              <a:defRPr sz="1133"/>
            </a:lvl1pPr>
            <a:lvl2pPr marL="323698" indent="0">
              <a:buNone/>
              <a:defRPr sz="991"/>
            </a:lvl2pPr>
            <a:lvl3pPr marL="647395" indent="0">
              <a:buNone/>
              <a:defRPr sz="850"/>
            </a:lvl3pPr>
            <a:lvl4pPr marL="971093" indent="0">
              <a:buNone/>
              <a:defRPr sz="708"/>
            </a:lvl4pPr>
            <a:lvl5pPr marL="1294790" indent="0">
              <a:buNone/>
              <a:defRPr sz="708"/>
            </a:lvl5pPr>
            <a:lvl6pPr marL="1618488" indent="0">
              <a:buNone/>
              <a:defRPr sz="708"/>
            </a:lvl6pPr>
            <a:lvl7pPr marL="1942186" indent="0">
              <a:buNone/>
              <a:defRPr sz="708"/>
            </a:lvl7pPr>
            <a:lvl8pPr marL="2265883" indent="0">
              <a:buNone/>
              <a:defRPr sz="708"/>
            </a:lvl8pPr>
            <a:lvl9pPr marL="2589581" indent="0">
              <a:buNone/>
              <a:defRPr sz="70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136405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5919" y="575416"/>
            <a:ext cx="2087977" cy="2013956"/>
          </a:xfrm>
        </p:spPr>
        <p:txBody>
          <a:bodyPr anchor="b"/>
          <a:lstStyle>
            <a:lvl1pPr>
              <a:defRPr sz="2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2219" y="1242740"/>
            <a:ext cx="3277374" cy="6133773"/>
          </a:xfrm>
        </p:spPr>
        <p:txBody>
          <a:bodyPr anchor="t"/>
          <a:lstStyle>
            <a:lvl1pPr marL="0" indent="0">
              <a:buNone/>
              <a:defRPr sz="2266"/>
            </a:lvl1pPr>
            <a:lvl2pPr marL="323698" indent="0">
              <a:buNone/>
              <a:defRPr sz="1982"/>
            </a:lvl2pPr>
            <a:lvl3pPr marL="647395" indent="0">
              <a:buNone/>
              <a:defRPr sz="1699"/>
            </a:lvl3pPr>
            <a:lvl4pPr marL="971093" indent="0">
              <a:buNone/>
              <a:defRPr sz="1416"/>
            </a:lvl4pPr>
            <a:lvl5pPr marL="1294790" indent="0">
              <a:buNone/>
              <a:defRPr sz="1416"/>
            </a:lvl5pPr>
            <a:lvl6pPr marL="1618488" indent="0">
              <a:buNone/>
              <a:defRPr sz="1416"/>
            </a:lvl6pPr>
            <a:lvl7pPr marL="1942186" indent="0">
              <a:buNone/>
              <a:defRPr sz="1416"/>
            </a:lvl7pPr>
            <a:lvl8pPr marL="2265883" indent="0">
              <a:buNone/>
              <a:defRPr sz="1416"/>
            </a:lvl8pPr>
            <a:lvl9pPr marL="2589581" indent="0">
              <a:buNone/>
              <a:defRPr sz="141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5919" y="2589371"/>
            <a:ext cx="2087977" cy="4797131"/>
          </a:xfrm>
        </p:spPr>
        <p:txBody>
          <a:bodyPr/>
          <a:lstStyle>
            <a:lvl1pPr marL="0" indent="0">
              <a:buNone/>
              <a:defRPr sz="1133"/>
            </a:lvl1pPr>
            <a:lvl2pPr marL="323698" indent="0">
              <a:buNone/>
              <a:defRPr sz="991"/>
            </a:lvl2pPr>
            <a:lvl3pPr marL="647395" indent="0">
              <a:buNone/>
              <a:defRPr sz="850"/>
            </a:lvl3pPr>
            <a:lvl4pPr marL="971093" indent="0">
              <a:buNone/>
              <a:defRPr sz="708"/>
            </a:lvl4pPr>
            <a:lvl5pPr marL="1294790" indent="0">
              <a:buNone/>
              <a:defRPr sz="708"/>
            </a:lvl5pPr>
            <a:lvl6pPr marL="1618488" indent="0">
              <a:buNone/>
              <a:defRPr sz="708"/>
            </a:lvl6pPr>
            <a:lvl7pPr marL="1942186" indent="0">
              <a:buNone/>
              <a:defRPr sz="708"/>
            </a:lvl7pPr>
            <a:lvl8pPr marL="2265883" indent="0">
              <a:buNone/>
              <a:defRPr sz="708"/>
            </a:lvl8pPr>
            <a:lvl9pPr marL="2589581" indent="0">
              <a:buNone/>
              <a:defRPr sz="70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462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076" y="459535"/>
            <a:ext cx="5583674" cy="16683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076" y="2297668"/>
            <a:ext cx="5583674" cy="54764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075" y="7999881"/>
            <a:ext cx="1456611" cy="4595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D3104-4258-4777-A921-86A52A3A2A7E}" type="datetimeFigureOut">
              <a:rPr lang="x-none" smtClean="0"/>
              <a:t>17-04-2023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4455" y="7999881"/>
            <a:ext cx="2184916" cy="4595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139" y="7999881"/>
            <a:ext cx="1456611" cy="4595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06245-2333-482E-BFB9-5E1F62A7D9A6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8324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7395" rtl="0" eaLnBrk="1" latinLnBrk="0" hangingPunct="1">
        <a:lnSpc>
          <a:spcPct val="90000"/>
        </a:lnSpc>
        <a:spcBef>
          <a:spcPct val="0"/>
        </a:spcBef>
        <a:buNone/>
        <a:defRPr sz="31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849" indent="-161849" algn="l" defTabSz="647395" rtl="0" eaLnBrk="1" latinLnBrk="0" hangingPunct="1">
        <a:lnSpc>
          <a:spcPct val="90000"/>
        </a:lnSpc>
        <a:spcBef>
          <a:spcPts val="708"/>
        </a:spcBef>
        <a:buFont typeface="Arial" panose="020B0604020202020204" pitchFamily="34" charset="0"/>
        <a:buChar char="•"/>
        <a:defRPr sz="1982" kern="1200">
          <a:solidFill>
            <a:schemeClr val="tx1"/>
          </a:solidFill>
          <a:latin typeface="+mn-lt"/>
          <a:ea typeface="+mn-ea"/>
          <a:cs typeface="+mn-cs"/>
        </a:defRPr>
      </a:lvl1pPr>
      <a:lvl2pPr marL="485546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699" kern="1200">
          <a:solidFill>
            <a:schemeClr val="tx1"/>
          </a:solidFill>
          <a:latin typeface="+mn-lt"/>
          <a:ea typeface="+mn-ea"/>
          <a:cs typeface="+mn-cs"/>
        </a:defRPr>
      </a:lvl2pPr>
      <a:lvl3pPr marL="809244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6" kern="1200">
          <a:solidFill>
            <a:schemeClr val="tx1"/>
          </a:solidFill>
          <a:latin typeface="+mn-lt"/>
          <a:ea typeface="+mn-ea"/>
          <a:cs typeface="+mn-cs"/>
        </a:defRPr>
      </a:lvl3pPr>
      <a:lvl4pPr marL="1132942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4pPr>
      <a:lvl5pPr marL="1456639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5pPr>
      <a:lvl6pPr marL="1780337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6pPr>
      <a:lvl7pPr marL="2104034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7pPr>
      <a:lvl8pPr marL="2427732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8pPr>
      <a:lvl9pPr marL="2751430" indent="-161849" algn="l" defTabSz="64739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1pPr>
      <a:lvl2pPr marL="323698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2pPr>
      <a:lvl3pPr marL="647395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3pPr>
      <a:lvl4pPr marL="971093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4pPr>
      <a:lvl5pPr marL="1294790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5pPr>
      <a:lvl6pPr marL="1618488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6pPr>
      <a:lvl7pPr marL="1942186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7pPr>
      <a:lvl8pPr marL="2265883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8pPr>
      <a:lvl9pPr marL="2589581" algn="l" defTabSz="647395" rtl="0" eaLnBrk="1" latinLnBrk="0" hangingPunct="1">
        <a:defRPr sz="12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calendar, scatter chart&#10;&#10;Description automatically generated">
            <a:extLst>
              <a:ext uri="{FF2B5EF4-FFF2-40B4-BE49-F238E27FC236}">
                <a16:creationId xmlns:a16="http://schemas.microsoft.com/office/drawing/2014/main" xmlns="" id="{D3AA212E-EB3C-BFD3-6078-63E0E981D4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402602" y="60352"/>
            <a:ext cx="3057644" cy="3718884"/>
          </a:xfrm>
          <a:prstGeom prst="rect">
            <a:avLst/>
          </a:prstGeom>
        </p:spPr>
      </p:pic>
      <p:pic>
        <p:nvPicPr>
          <p:cNvPr id="5" name="Picture 4" descr="Diagram, timeline&#10;&#10;Description automatically generated">
            <a:extLst>
              <a:ext uri="{FF2B5EF4-FFF2-40B4-BE49-F238E27FC236}">
                <a16:creationId xmlns:a16="http://schemas.microsoft.com/office/drawing/2014/main" xmlns="" id="{87972ACC-DFBC-B7ED-A279-04B336E2EE4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982" y="4311175"/>
            <a:ext cx="3718884" cy="305764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1038B903-1F73-D20B-3D4B-3C79C80DE97C}"/>
              </a:ext>
            </a:extLst>
          </p:cNvPr>
          <p:cNvSpPr txBox="1"/>
          <p:nvPr/>
        </p:nvSpPr>
        <p:spPr>
          <a:xfrm>
            <a:off x="497217" y="1067840"/>
            <a:ext cx="15747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RNA Control</a:t>
            </a: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RNA SGO1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F1CA0C3E-1D14-D854-6DCD-1616080F53A8}"/>
              </a:ext>
            </a:extLst>
          </p:cNvPr>
          <p:cNvSpPr txBox="1"/>
          <p:nvPr/>
        </p:nvSpPr>
        <p:spPr>
          <a:xfrm>
            <a:off x="497216" y="4458668"/>
            <a:ext cx="1574766" cy="2326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endParaRPr lang="en-US" sz="203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203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203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RNA Control</a:t>
            </a: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RNA SGO1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65E507F-FA29-4ACC-A2E4-9C8B62574C44}"/>
              </a:ext>
            </a:extLst>
          </p:cNvPr>
          <p:cNvSpPr txBox="1"/>
          <p:nvPr/>
        </p:nvSpPr>
        <p:spPr>
          <a:xfrm>
            <a:off x="184620" y="15681"/>
            <a:ext cx="300235" cy="47993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			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1D3B6D4-FBD9-C8DF-004E-CE51AF8FAEED}"/>
              </a:ext>
            </a:extLst>
          </p:cNvPr>
          <p:cNvSpPr txBox="1"/>
          <p:nvPr/>
        </p:nvSpPr>
        <p:spPr>
          <a:xfrm>
            <a:off x="1875" y="7664702"/>
            <a:ext cx="647194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of primary tumors recovered from NSG mice treated with MDA-MB-231 cells expressing shRNA Control (5-10) or shRNA SGO1 (15-20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-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C4AF68D-C6D8-41C8-85FF-24CDC24ACF6C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9848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6AF84223-C257-9E8F-883C-238F580C12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819" y="4623084"/>
            <a:ext cx="3522066" cy="285909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757AA9CA-2451-9E70-C851-2FA14231FF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820" y="690612"/>
            <a:ext cx="3522066" cy="285909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9556DB92-68ED-F3F8-649F-8F728E758188}"/>
              </a:ext>
            </a:extLst>
          </p:cNvPr>
          <p:cNvSpPr txBox="1"/>
          <p:nvPr/>
        </p:nvSpPr>
        <p:spPr>
          <a:xfrm>
            <a:off x="12509" y="15682"/>
            <a:ext cx="300235" cy="4485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			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B228002D-B7EE-7C6F-98DE-78287E241658}"/>
              </a:ext>
            </a:extLst>
          </p:cNvPr>
          <p:cNvSpPr txBox="1"/>
          <p:nvPr/>
        </p:nvSpPr>
        <p:spPr>
          <a:xfrm>
            <a:off x="4979741" y="5948852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xmlns="" id="{F588D829-0950-B5A8-56C2-EBE84E8977F2}"/>
              </a:ext>
            </a:extLst>
          </p:cNvPr>
          <p:cNvCxnSpPr/>
          <p:nvPr/>
        </p:nvCxnSpPr>
        <p:spPr>
          <a:xfrm flipH="1">
            <a:off x="4105937" y="6105742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876B024-D688-4C75-18D2-047F0F62ADB7}"/>
              </a:ext>
            </a:extLst>
          </p:cNvPr>
          <p:cNvSpPr txBox="1"/>
          <p:nvPr/>
        </p:nvSpPr>
        <p:spPr>
          <a:xfrm>
            <a:off x="4930178" y="1484989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GO1 (7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xmlns="" id="{3F609975-F1C8-19D2-BF1E-543F70C4D122}"/>
              </a:ext>
            </a:extLst>
          </p:cNvPr>
          <p:cNvCxnSpPr/>
          <p:nvPr/>
        </p:nvCxnSpPr>
        <p:spPr>
          <a:xfrm flipH="1">
            <a:off x="4056372" y="1641877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83219DF0-751F-48FC-547C-A26ECC6499B1}"/>
              </a:ext>
            </a:extLst>
          </p:cNvPr>
          <p:cNvSpPr txBox="1"/>
          <p:nvPr/>
        </p:nvSpPr>
        <p:spPr>
          <a:xfrm>
            <a:off x="1193475" y="380717"/>
            <a:ext cx="2501106" cy="3014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2     3   4     5    6      7    8</a:t>
            </a:r>
            <a:endParaRPr lang="x-none" sz="135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A0C0BDE6-F7C8-6577-48D8-611F9AA0E1F5}"/>
              </a:ext>
            </a:extLst>
          </p:cNvPr>
          <p:cNvSpPr txBox="1"/>
          <p:nvPr/>
        </p:nvSpPr>
        <p:spPr>
          <a:xfrm>
            <a:off x="1120865" y="4318645"/>
            <a:ext cx="2501106" cy="3014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9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 2      3    4      5     6    7    8</a:t>
            </a:r>
            <a:endParaRPr lang="x-none" sz="135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EAEADAD-7F63-C982-6F32-D0436A83CC23}"/>
              </a:ext>
            </a:extLst>
          </p:cNvPr>
          <p:cNvSpPr txBox="1"/>
          <p:nvPr/>
        </p:nvSpPr>
        <p:spPr>
          <a:xfrm>
            <a:off x="12509" y="7745625"/>
            <a:ext cx="64613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SGO1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tumor lysates from NSG mice treated with MDA-MB-231 cells expressing shRNA Control (1-4) or shRNA SGO1 (5-8). 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5C4BD10D-D438-4D8D-A9CA-3166D0E8E78E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700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13EE2064-1295-6FFE-86E4-2714292A57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3455" y="572979"/>
            <a:ext cx="2501106" cy="203031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85DAA7E4-F34E-4253-75B6-70C37E6648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3455" y="3207408"/>
            <a:ext cx="2501106" cy="203031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7F297B89-6E88-4BC5-CA8C-3FA912D8CC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3455" y="5738097"/>
            <a:ext cx="2501106" cy="207091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8290EDCB-55EC-9EFB-305A-D465FEF1F7BB}"/>
              </a:ext>
            </a:extLst>
          </p:cNvPr>
          <p:cNvSpPr txBox="1"/>
          <p:nvPr/>
        </p:nvSpPr>
        <p:spPr>
          <a:xfrm>
            <a:off x="370216" y="224131"/>
            <a:ext cx="615703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20B37692-CD7E-6C4B-F425-2F739F5F5563}"/>
              </a:ext>
            </a:extLst>
          </p:cNvPr>
          <p:cNvSpPr txBox="1"/>
          <p:nvPr/>
        </p:nvSpPr>
        <p:spPr>
          <a:xfrm>
            <a:off x="4512380" y="1506306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GO1 (7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xmlns="" id="{A5599604-1EB8-1AE1-36A7-830BD2A2B00B}"/>
              </a:ext>
            </a:extLst>
          </p:cNvPr>
          <p:cNvCxnSpPr/>
          <p:nvPr/>
        </p:nvCxnSpPr>
        <p:spPr>
          <a:xfrm flipH="1">
            <a:off x="3638574" y="1663195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3F9B0DEE-69A5-81CE-1E4C-E7CFE400F2F4}"/>
              </a:ext>
            </a:extLst>
          </p:cNvPr>
          <p:cNvSpPr txBox="1"/>
          <p:nvPr/>
        </p:nvSpPr>
        <p:spPr>
          <a:xfrm>
            <a:off x="1003456" y="280978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1   2      3   4    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90198280-11AC-8854-E37B-0323B309B675}"/>
              </a:ext>
            </a:extLst>
          </p:cNvPr>
          <p:cNvSpPr txBox="1"/>
          <p:nvPr/>
        </p:nvSpPr>
        <p:spPr>
          <a:xfrm>
            <a:off x="1543999" y="2898446"/>
            <a:ext cx="1960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2      3   4   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4DCF5BCA-8A10-B648-0B97-82EF99309C38}"/>
              </a:ext>
            </a:extLst>
          </p:cNvPr>
          <p:cNvSpPr txBox="1"/>
          <p:nvPr/>
        </p:nvSpPr>
        <p:spPr>
          <a:xfrm>
            <a:off x="4527361" y="4730420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nail (29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xmlns="" id="{D163FBDB-0DBF-9029-B0E2-1570D64427A8}"/>
              </a:ext>
            </a:extLst>
          </p:cNvPr>
          <p:cNvCxnSpPr/>
          <p:nvPr/>
        </p:nvCxnSpPr>
        <p:spPr>
          <a:xfrm flipH="1">
            <a:off x="3653555" y="4887310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0AF1A57-2956-F981-7DA3-83D545D76C4B}"/>
              </a:ext>
            </a:extLst>
          </p:cNvPr>
          <p:cNvSpPr txBox="1"/>
          <p:nvPr/>
        </p:nvSpPr>
        <p:spPr>
          <a:xfrm>
            <a:off x="1528156" y="5440504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2        3   4 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0DC473D9-24D2-7B31-7BBA-D7C354AF4DEA}"/>
              </a:ext>
            </a:extLst>
          </p:cNvPr>
          <p:cNvSpPr txBox="1"/>
          <p:nvPr/>
        </p:nvSpPr>
        <p:spPr>
          <a:xfrm>
            <a:off x="4511864" y="7048767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xmlns="" id="{BACFE982-E179-D83C-6149-9EFCEDBF335F}"/>
              </a:ext>
            </a:extLst>
          </p:cNvPr>
          <p:cNvCxnSpPr/>
          <p:nvPr/>
        </p:nvCxnSpPr>
        <p:spPr>
          <a:xfrm flipH="1">
            <a:off x="3638059" y="7205656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44CB6C8B-F4EB-4FEF-A649-6D49CBE22234}"/>
              </a:ext>
            </a:extLst>
          </p:cNvPr>
          <p:cNvSpPr txBox="1"/>
          <p:nvPr/>
        </p:nvSpPr>
        <p:spPr>
          <a:xfrm>
            <a:off x="-1" y="7927937"/>
            <a:ext cx="647382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SGO1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nail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MDA-MB-231 cells expressing shRNA Control (1, 3, and 5) or shRNA SGO1 (2, 4, and 6) from three independent experiments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E82FB87-2117-41C6-87E3-4FD4A8E7E349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5401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AE239CEE-18D7-1729-C607-1438DE3417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0113" y="987488"/>
            <a:ext cx="2299059" cy="189419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E23A40A-F3EF-C5E4-E6DA-0E93CF649C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4933" y="3382958"/>
            <a:ext cx="2294239" cy="189419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7B97A1F-D4E6-B87A-ED10-459C9DA578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4933" y="5751723"/>
            <a:ext cx="2294239" cy="189419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AAF1823E-CAAF-F2AC-0CD7-E094C67B14D7}"/>
              </a:ext>
            </a:extLst>
          </p:cNvPr>
          <p:cNvSpPr txBox="1"/>
          <p:nvPr/>
        </p:nvSpPr>
        <p:spPr>
          <a:xfrm>
            <a:off x="4164429" y="6776593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1004E707-D5CA-074E-2675-1DA9F2EE50D0}"/>
              </a:ext>
            </a:extLst>
          </p:cNvPr>
          <p:cNvCxnSpPr/>
          <p:nvPr/>
        </p:nvCxnSpPr>
        <p:spPr>
          <a:xfrm flipH="1">
            <a:off x="3290625" y="6933481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BA22B53-FDC9-A0EF-4CAA-517335A70456}"/>
              </a:ext>
            </a:extLst>
          </p:cNvPr>
          <p:cNvSpPr txBox="1"/>
          <p:nvPr/>
        </p:nvSpPr>
        <p:spPr>
          <a:xfrm>
            <a:off x="1422830" y="681250"/>
            <a:ext cx="1783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2     3   4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53735B4D-5D03-B546-CE55-96B080376D47}"/>
              </a:ext>
            </a:extLst>
          </p:cNvPr>
          <p:cNvSpPr txBox="1"/>
          <p:nvPr/>
        </p:nvSpPr>
        <p:spPr>
          <a:xfrm>
            <a:off x="4196039" y="2479289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lug (3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xmlns="" id="{5B07C2D3-A32B-7349-A367-EAAE0795F452}"/>
              </a:ext>
            </a:extLst>
          </p:cNvPr>
          <p:cNvCxnSpPr/>
          <p:nvPr/>
        </p:nvCxnSpPr>
        <p:spPr>
          <a:xfrm flipH="1">
            <a:off x="3322234" y="2636178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BB65278E-7AEE-6D4E-6555-D7A414FE347D}"/>
              </a:ext>
            </a:extLst>
          </p:cNvPr>
          <p:cNvSpPr txBox="1"/>
          <p:nvPr/>
        </p:nvSpPr>
        <p:spPr>
          <a:xfrm>
            <a:off x="1369365" y="3083227"/>
            <a:ext cx="18937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2       3   4   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323EDC1-34B9-B275-6545-5ABEFDC77DF9}"/>
              </a:ext>
            </a:extLst>
          </p:cNvPr>
          <p:cNvSpPr txBox="1"/>
          <p:nvPr/>
        </p:nvSpPr>
        <p:spPr>
          <a:xfrm>
            <a:off x="4180276" y="3951204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eb1 (2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xmlns="" id="{E4DA4876-0348-78DA-F1E8-35656CD3F5CE}"/>
              </a:ext>
            </a:extLst>
          </p:cNvPr>
          <p:cNvCxnSpPr/>
          <p:nvPr/>
        </p:nvCxnSpPr>
        <p:spPr>
          <a:xfrm flipH="1">
            <a:off x="3306470" y="4108093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25558470-89FF-13A3-FD48-07A1B68643D7}"/>
              </a:ext>
            </a:extLst>
          </p:cNvPr>
          <p:cNvSpPr txBox="1"/>
          <p:nvPr/>
        </p:nvSpPr>
        <p:spPr>
          <a:xfrm>
            <a:off x="1390280" y="5446686"/>
            <a:ext cx="1854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2        3  4        5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FCA9A1B0-D8A7-AE25-2551-FBB693544FB4}"/>
              </a:ext>
            </a:extLst>
          </p:cNvPr>
          <p:cNvSpPr txBox="1"/>
          <p:nvPr/>
        </p:nvSpPr>
        <p:spPr>
          <a:xfrm>
            <a:off x="285314" y="627350"/>
            <a:ext cx="615703" cy="5170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D4D93363-6E25-C546-4664-8A6F710CAC0C}"/>
              </a:ext>
            </a:extLst>
          </p:cNvPr>
          <p:cNvSpPr txBox="1"/>
          <p:nvPr/>
        </p:nvSpPr>
        <p:spPr>
          <a:xfrm>
            <a:off x="-5865" y="7902666"/>
            <a:ext cx="647968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Slug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Zeb1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in MDA-MB-231 cells expressing shRNA Control (1, 3, and 5) or shRNA SGO1 (2, 4, and 6) from three independent experiments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0C27C79B-7325-4497-8C73-7607BEF519F1}"/>
              </a:ext>
            </a:extLst>
          </p:cNvPr>
          <p:cNvSpPr txBox="1"/>
          <p:nvPr/>
        </p:nvSpPr>
        <p:spPr>
          <a:xfrm>
            <a:off x="2669539" y="-4513"/>
            <a:ext cx="20521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6254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69B8B883-B3A1-5FC4-3949-76639464F7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5533" y="602373"/>
            <a:ext cx="3287263" cy="271406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618FBE8A-C321-A323-85C2-DD0903213C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5533" y="4695624"/>
            <a:ext cx="3287263" cy="271406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BB19815E-D0F9-351B-209B-84A1A390B590}"/>
              </a:ext>
            </a:extLst>
          </p:cNvPr>
          <p:cNvSpPr txBox="1"/>
          <p:nvPr/>
        </p:nvSpPr>
        <p:spPr>
          <a:xfrm>
            <a:off x="4895022" y="6501218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xmlns="" id="{D3F8C140-691D-3860-DDE0-9C23A1280387}"/>
              </a:ext>
            </a:extLst>
          </p:cNvPr>
          <p:cNvCxnSpPr/>
          <p:nvPr/>
        </p:nvCxnSpPr>
        <p:spPr>
          <a:xfrm flipH="1">
            <a:off x="4021216" y="6658106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4D0E1AC6-348A-6815-0DCA-C6166684BF8E}"/>
              </a:ext>
            </a:extLst>
          </p:cNvPr>
          <p:cNvSpPr txBox="1"/>
          <p:nvPr/>
        </p:nvSpPr>
        <p:spPr>
          <a:xfrm>
            <a:off x="4892133" y="2967204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wist1 (3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xmlns="" id="{5A35C304-31BA-9899-4519-CFAB7C48AD61}"/>
              </a:ext>
            </a:extLst>
          </p:cNvPr>
          <p:cNvCxnSpPr/>
          <p:nvPr/>
        </p:nvCxnSpPr>
        <p:spPr>
          <a:xfrm flipH="1">
            <a:off x="4018328" y="3124092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17AF31ED-DFA8-300A-E479-67FC69479FCD}"/>
              </a:ext>
            </a:extLst>
          </p:cNvPr>
          <p:cNvSpPr txBox="1"/>
          <p:nvPr/>
        </p:nvSpPr>
        <p:spPr>
          <a:xfrm>
            <a:off x="1371702" y="304837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    2          3    4         5 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90FAADF8-7441-73AC-38D0-5362C137B4C9}"/>
              </a:ext>
            </a:extLst>
          </p:cNvPr>
          <p:cNvSpPr txBox="1"/>
          <p:nvPr/>
        </p:nvSpPr>
        <p:spPr>
          <a:xfrm>
            <a:off x="1305375" y="4368615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2          3    4          5 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B29A28F-562A-B6FF-06DA-389B7BA8DEF8}"/>
              </a:ext>
            </a:extLst>
          </p:cNvPr>
          <p:cNvSpPr txBox="1"/>
          <p:nvPr/>
        </p:nvSpPr>
        <p:spPr>
          <a:xfrm>
            <a:off x="12509" y="29538"/>
            <a:ext cx="300235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			</a:t>
            </a: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9384E0F6-5B08-F0F6-047D-F73A50F36F00}"/>
              </a:ext>
            </a:extLst>
          </p:cNvPr>
          <p:cNvSpPr txBox="1"/>
          <p:nvPr/>
        </p:nvSpPr>
        <p:spPr>
          <a:xfrm>
            <a:off x="12509" y="7680752"/>
            <a:ext cx="64613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5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Tiwst1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in MDA-MB-231 cells expressing shRNA Control (1, 3, and 5) or shRNA SGO1 (2, 4, and 6) from three independent experiments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2C11A73-172A-41F0-9F6E-35AC9D60EE4C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87329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11A819F-0D1C-4F88-04B7-D027A7B2B454}"/>
              </a:ext>
            </a:extLst>
          </p:cNvPr>
          <p:cNvSpPr txBox="1"/>
          <p:nvPr/>
        </p:nvSpPr>
        <p:spPr>
          <a:xfrm>
            <a:off x="4967232" y="6308237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E6E48F82-C4C8-CC1C-0FF7-60120E001BE4}"/>
              </a:ext>
            </a:extLst>
          </p:cNvPr>
          <p:cNvSpPr txBox="1"/>
          <p:nvPr/>
        </p:nvSpPr>
        <p:spPr>
          <a:xfrm>
            <a:off x="4995998" y="1352968"/>
            <a:ext cx="1456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O1 (22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D4039090-0DAD-A6F2-8DFC-595F75C812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115" y="879492"/>
            <a:ext cx="3577314" cy="249307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4CBEAFC3-567C-B79D-80DA-3242AEDED9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115" y="4777897"/>
            <a:ext cx="3577314" cy="24930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28F1BD1-D4A4-E4C8-F833-4560A970C748}"/>
              </a:ext>
            </a:extLst>
          </p:cNvPr>
          <p:cNvSpPr txBox="1"/>
          <p:nvPr/>
        </p:nvSpPr>
        <p:spPr>
          <a:xfrm>
            <a:off x="1341689" y="563702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 2            3     4           5 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F0E2C71-E8EB-0082-7573-8A0E23228F1A}"/>
              </a:ext>
            </a:extLst>
          </p:cNvPr>
          <p:cNvSpPr txBox="1"/>
          <p:nvPr/>
        </p:nvSpPr>
        <p:spPr>
          <a:xfrm>
            <a:off x="1226005" y="4456980"/>
            <a:ext cx="2501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    2            3     4           5 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xmlns="" id="{597A8058-0575-C4FF-921A-9927574E1FB3}"/>
              </a:ext>
            </a:extLst>
          </p:cNvPr>
          <p:cNvCxnSpPr/>
          <p:nvPr/>
        </p:nvCxnSpPr>
        <p:spPr>
          <a:xfrm flipH="1">
            <a:off x="4096106" y="1509856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xmlns="" id="{EB5DD770-C2D1-AA7C-F2C6-839731CB984C}"/>
              </a:ext>
            </a:extLst>
          </p:cNvPr>
          <p:cNvCxnSpPr/>
          <p:nvPr/>
        </p:nvCxnSpPr>
        <p:spPr>
          <a:xfrm flipH="1">
            <a:off x="4093426" y="6465126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555B2E7-1822-84DB-8F8F-585358E6260F}"/>
              </a:ext>
            </a:extLst>
          </p:cNvPr>
          <p:cNvSpPr txBox="1"/>
          <p:nvPr/>
        </p:nvSpPr>
        <p:spPr>
          <a:xfrm>
            <a:off x="176009" y="15678"/>
            <a:ext cx="300235" cy="719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	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3A970EF-5892-DD62-5969-907B5335C545}"/>
              </a:ext>
            </a:extLst>
          </p:cNvPr>
          <p:cNvSpPr txBox="1"/>
          <p:nvPr/>
        </p:nvSpPr>
        <p:spPr>
          <a:xfrm>
            <a:off x="178368" y="3937703"/>
            <a:ext cx="676197" cy="406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2039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B969D56-D82A-48E9-6652-98D5B58EE502}"/>
              </a:ext>
            </a:extLst>
          </p:cNvPr>
          <p:cNvSpPr txBox="1"/>
          <p:nvPr/>
        </p:nvSpPr>
        <p:spPr>
          <a:xfrm>
            <a:off x="1876" y="7545924"/>
            <a:ext cx="645066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6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ZO1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MDA-MB-231 cells expressing shRNA Control (1, 3, and 5) or shRNA SGO1 (2, 4, and 6) from three independent experiments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2EB5185-1258-42A2-9AE8-9981C2BEF5FC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55358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BF51D07A-6E5E-FCD5-82C0-75182212FF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602" y="4954635"/>
            <a:ext cx="3577314" cy="249307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4ECC5418-999D-DD53-3D2A-2F7AB94C22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602" y="999871"/>
            <a:ext cx="3577314" cy="24930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653DAF8-994D-803B-983E-EC4BB80F646D}"/>
              </a:ext>
            </a:extLst>
          </p:cNvPr>
          <p:cNvSpPr txBox="1"/>
          <p:nvPr/>
        </p:nvSpPr>
        <p:spPr>
          <a:xfrm>
            <a:off x="4689485" y="1866886"/>
            <a:ext cx="1764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-cadherin (13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xmlns="" id="{712C1F6C-3E02-56D5-3C45-7BF52F944E16}"/>
              </a:ext>
            </a:extLst>
          </p:cNvPr>
          <p:cNvCxnSpPr/>
          <p:nvPr/>
        </p:nvCxnSpPr>
        <p:spPr>
          <a:xfrm flipH="1">
            <a:off x="3789594" y="2023775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7AC97D8-7CDB-B58D-94AA-E85A61ECF592}"/>
              </a:ext>
            </a:extLst>
          </p:cNvPr>
          <p:cNvSpPr txBox="1"/>
          <p:nvPr/>
        </p:nvSpPr>
        <p:spPr>
          <a:xfrm>
            <a:off x="4689485" y="2292065"/>
            <a:ext cx="1764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xmlns="" id="{BF915583-2DF9-2B58-5DA5-8D5B803F5C28}"/>
              </a:ext>
            </a:extLst>
          </p:cNvPr>
          <p:cNvCxnSpPr/>
          <p:nvPr/>
        </p:nvCxnSpPr>
        <p:spPr>
          <a:xfrm flipH="1">
            <a:off x="3789594" y="2448954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96B4144-910A-1933-CECE-CA08C249D96E}"/>
              </a:ext>
            </a:extLst>
          </p:cNvPr>
          <p:cNvSpPr txBox="1"/>
          <p:nvPr/>
        </p:nvSpPr>
        <p:spPr>
          <a:xfrm>
            <a:off x="4726086" y="6246828"/>
            <a:ext cx="1506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actin (47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B0EA0503-B7ED-94D8-082D-4C9F755602C8}"/>
              </a:ext>
            </a:extLst>
          </p:cNvPr>
          <p:cNvCxnSpPr/>
          <p:nvPr/>
        </p:nvCxnSpPr>
        <p:spPr>
          <a:xfrm flipH="1">
            <a:off x="3852281" y="6403717"/>
            <a:ext cx="80843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E892122-FA11-42BF-A239-42B0BF353F39}"/>
              </a:ext>
            </a:extLst>
          </p:cNvPr>
          <p:cNvSpPr txBox="1"/>
          <p:nvPr/>
        </p:nvSpPr>
        <p:spPr>
          <a:xfrm>
            <a:off x="540536" y="700698"/>
            <a:ext cx="2882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     2              3      4               5     6 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D1F8E8B-86FE-3918-BB77-F09D40AA47E1}"/>
              </a:ext>
            </a:extLst>
          </p:cNvPr>
          <p:cNvSpPr txBox="1"/>
          <p:nvPr/>
        </p:nvSpPr>
        <p:spPr>
          <a:xfrm>
            <a:off x="425853" y="4625601"/>
            <a:ext cx="2882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      2            3      4            5      6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A65E215-DB4A-E6A9-A61B-C3202A02C71F}"/>
              </a:ext>
            </a:extLst>
          </p:cNvPr>
          <p:cNvSpPr txBox="1"/>
          <p:nvPr/>
        </p:nvSpPr>
        <p:spPr>
          <a:xfrm>
            <a:off x="3764" y="1093"/>
            <a:ext cx="300235" cy="719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	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0E81CE81-E822-4AD9-F279-703AED561328}"/>
              </a:ext>
            </a:extLst>
          </p:cNvPr>
          <p:cNvSpPr txBox="1"/>
          <p:nvPr/>
        </p:nvSpPr>
        <p:spPr>
          <a:xfrm>
            <a:off x="6123" y="4191973"/>
            <a:ext cx="676197" cy="406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2039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999686CD-7974-15C8-26D6-3B8F5F9A6E96}"/>
              </a:ext>
            </a:extLst>
          </p:cNvPr>
          <p:cNvSpPr txBox="1"/>
          <p:nvPr/>
        </p:nvSpPr>
        <p:spPr>
          <a:xfrm>
            <a:off x="0" y="7715106"/>
            <a:ext cx="64542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7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iginal Western blot films showing E-cadherin and Vimen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β-actin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MDA-MB-231 cells expressing shRNA Control (1, 3, and 5) or shRNA SGO1 (2, 4, and 6) from three independent experiments.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8CB94651-A586-40FF-9669-9BB80CFE00B7}"/>
              </a:ext>
            </a:extLst>
          </p:cNvPr>
          <p:cNvSpPr txBox="1"/>
          <p:nvPr/>
        </p:nvSpPr>
        <p:spPr>
          <a:xfrm>
            <a:off x="2669539" y="-4513"/>
            <a:ext cx="2002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8004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9</TotalTime>
  <Words>553</Words>
  <Application>Microsoft Office PowerPoint</Application>
  <PresentationFormat>Custom</PresentationFormat>
  <Paragraphs>13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Western Blot Films</dc:title>
  <dc:creator>Shirley</dc:creator>
  <cp:lastModifiedBy>Sangeetha Nanda Gopal</cp:lastModifiedBy>
  <cp:revision>29</cp:revision>
  <dcterms:created xsi:type="dcterms:W3CDTF">2022-07-23T16:33:52Z</dcterms:created>
  <dcterms:modified xsi:type="dcterms:W3CDTF">2023-04-17T04:49:53Z</dcterms:modified>
</cp:coreProperties>
</file>